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4D673-C194-492E-99D6-17C3E5D3D1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EF74D-1996-4956-8E4F-2D2F44A63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E2208-5065-4DD9-AEEE-76AF2C6453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70D28-AA7F-4C6E-B4D3-2F149DAD0D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6A640-2D2F-4465-8CE1-5820ADFDE2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44A96-87C6-4EF9-8E83-5925961827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A5DAD-0F4E-4B73-B93E-C9BBEDB6DC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208B2-9DB8-4B2B-B30D-C7D3DA3E1C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3FF80-1F69-4783-BC01-43B5A20DD0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1FF99-C5B4-4998-BF06-5AA4001742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3F94A-5AE1-4AB9-8C70-01D461608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88765-7908-4899-9C31-DC16488CBF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DFA6AF-2578-4C04-9FAD-84C4487663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0880" y="762120"/>
            <a:ext cx="662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Control of rundown effects of glycine recep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14"/>
          <p:cNvSpPr/>
          <p:nvPr/>
        </p:nvSpPr>
        <p:spPr>
          <a:xfrm>
            <a:off x="380880" y="228600"/>
            <a:ext cx="381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dditional file 2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06"/>
          <p:cNvSpPr/>
          <p:nvPr/>
        </p:nvSpPr>
        <p:spPr>
          <a:xfrm>
            <a:off x="380880" y="1295280"/>
            <a:ext cx="6248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races for R271K with 10 mM glycine solution as control before and after each agonist/drug application (for analysis currents were normalized to the mean value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4952880" y="3200400"/>
            <a:ext cx="3900600" cy="25099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685800" y="6019920"/>
            <a:ext cx="792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Initial current amplitude size of glycine before and after co-application almost remain const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06"/>
          <p:cNvSpPr/>
          <p:nvPr/>
        </p:nvSpPr>
        <p:spPr>
          <a:xfrm>
            <a:off x="5181480" y="2666880"/>
            <a:ext cx="3124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races for WT with 10 µM glycine before and after application of ethanol (EtO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00400" y="4038480"/>
            <a:ext cx="17524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1 nM 4-chloropropofo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in 100 µM glyc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152280" y="2057400"/>
            <a:ext cx="4492800" cy="3908520"/>
            <a:chOff x="152280" y="2057400"/>
            <a:chExt cx="4492800" cy="3908520"/>
          </a:xfrm>
        </p:grpSpPr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152280" y="2133720"/>
              <a:ext cx="3081600" cy="383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 Box 2627"/>
            <p:cNvSpPr/>
            <p:nvPr/>
          </p:nvSpPr>
          <p:spPr>
            <a:xfrm>
              <a:off x="3276720" y="2057400"/>
              <a:ext cx="136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0 mM glyc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627"/>
            <p:cNvSpPr/>
            <p:nvPr/>
          </p:nvSpPr>
          <p:spPr>
            <a:xfrm>
              <a:off x="3200400" y="3429000"/>
              <a:ext cx="136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0 mM glyc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627"/>
            <p:cNvSpPr/>
            <p:nvPr/>
          </p:nvSpPr>
          <p:spPr>
            <a:xfrm>
              <a:off x="3200400" y="4800600"/>
              <a:ext cx="136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0 mM glyc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627"/>
            <p:cNvSpPr/>
            <p:nvPr/>
          </p:nvSpPr>
          <p:spPr>
            <a:xfrm>
              <a:off x="3200400" y="2971800"/>
              <a:ext cx="129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00 µM glyc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Jeanne de la Roche</cp:lastModifiedBy>
  <dcterms:modified xsi:type="dcterms:W3CDTF">2012-08-23T14:35:44Z</dcterms:modified>
  <cp:revision>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